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9360">
            <a:noFill/>
          </a:ln>
        </p:spPr>
        <p:txBody>
          <a:bodyPr lIns="90000" rIns="90000" tIns="45000" bIns="45000" anchor="ctr" anchorCtr="1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sldImg"/>
          </p:nvPr>
        </p:nvSpPr>
        <p:spPr>
          <a:xfrm>
            <a:off x="1371600" y="763200"/>
            <a:ext cx="5027760" cy="3770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>
              <a:lnSpc>
                <a:spcPct val="10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body"/>
          </p:nvPr>
        </p:nvSpPr>
        <p:spPr>
          <a:xfrm>
            <a:off x="777960" y="4776840"/>
            <a:ext cx="62164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hdr"/>
          </p:nvPr>
        </p:nvSpPr>
        <p:spPr>
          <a:xfrm>
            <a:off x="0" y="-360"/>
            <a:ext cx="3371760" cy="501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lnSpc>
                <a:spcPct val="95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head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dt" idx="3"/>
          </p:nvPr>
        </p:nvSpPr>
        <p:spPr>
          <a:xfrm>
            <a:off x="4398480" y="-360"/>
            <a:ext cx="3372120" cy="501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 algn="r">
              <a:lnSpc>
                <a:spcPct val="95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lnSpc>
                <a:spcPct val="95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4"/>
          </p:nvPr>
        </p:nvSpPr>
        <p:spPr>
          <a:xfrm>
            <a:off x="0" y="9555120"/>
            <a:ext cx="3371760" cy="501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>
              <a:lnSpc>
                <a:spcPct val="95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lnSpc>
                <a:spcPct val="95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5"/>
          </p:nvPr>
        </p:nvSpPr>
        <p:spPr>
          <a:xfrm>
            <a:off x="4398480" y="9555120"/>
            <a:ext cx="3372120" cy="501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95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lnSpc>
                <a:spcPct val="95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DBE66C42-82D6-4C6A-B687-63C850867A30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"/>
          <p:cNvSpPr/>
          <p:nvPr/>
        </p:nvSpPr>
        <p:spPr>
          <a:xfrm>
            <a:off x="0" y="0"/>
            <a:ext cx="1440" cy="1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-44280" bIns="-900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31499FFE-E081-4A11-BF16-B75E9BC1F1EE}" type="slidenum">
              <a:rPr b="0" lang="en-US" sz="1800" spc="-1" strike="noStrike">
                <a:solidFill>
                  <a:srgbClr val="000000"/>
                </a:solidFill>
                <a:latin typeface="+mn-lt"/>
                <a:ea typeface="+mn-ea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90" name="PlaceHolder 2"/>
          <p:cNvSpPr>
            <a:spLocks noGrp="1"/>
          </p:cNvSpPr>
          <p:nvPr>
            <p:ph type="body"/>
          </p:nvPr>
        </p:nvSpPr>
        <p:spPr>
          <a:xfrm>
            <a:off x="914400" y="4338720"/>
            <a:ext cx="5029200" cy="41241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4680" rIns="4680" tIns="4680" bIns="468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  <a:ea typeface="Arial Unicode MS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6FF2175-59BA-4267-81C8-F743B7D2D335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3080" y="528444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E46BA16-9559-4E51-8067-E27BE9066F1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496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F6AC428-C81A-4DFE-85F6-8B45AF408E3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2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54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30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2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54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4CA2BF6-DEA9-41F9-96F2-04368AD2A16F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BB61F95B-8450-468B-A778-6AF32089065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515C16A-E606-4FF0-BBB6-E789D5AB814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466E4A8-706F-48A7-A203-F1CAA60490F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6FC58A8-CD55-462C-8D41-0D990249223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3080" y="366480"/>
            <a:ext cx="6170400" cy="705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897CAAA-0D51-4E68-BD69-453878872F3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3DF3B39-AA22-44B2-AD8B-35C152EB274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496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63FA20A-4AD2-417C-B983-226E7D2AAFE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967DF8E-355E-4AF1-A458-79DECF5C2E6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3080" y="8475840"/>
            <a:ext cx="1598400" cy="483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8b8b8b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8b8b8b"/>
                </a:solidFill>
                <a:latin typeface="Calibri"/>
              </a:rPr>
              <a:t>7/10/1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"/>
          <p:cNvSpPr/>
          <p:nvPr/>
        </p:nvSpPr>
        <p:spPr>
          <a:xfrm>
            <a:off x="2343240" y="8475840"/>
            <a:ext cx="2171520" cy="48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sldNum" idx="2"/>
          </p:nvPr>
        </p:nvSpPr>
        <p:spPr>
          <a:xfrm>
            <a:off x="4915080" y="8475840"/>
            <a:ext cx="1598400" cy="483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8b8b8b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FD25FE05-AC98-437F-A646-7F0CCA030E89}" type="slidenum">
              <a:rPr b="0" lang="en-US" sz="1800" spc="-1" strike="noStrike">
                <a:solidFill>
                  <a:srgbClr val="8b8b8b"/>
                </a:solidFill>
                <a:latin typeface="Calibri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"/>
          <p:cNvSpPr/>
          <p:nvPr/>
        </p:nvSpPr>
        <p:spPr>
          <a:xfrm>
            <a:off x="5423040" y="7454880"/>
            <a:ext cx="183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356760" y="8112240"/>
            <a:ext cx="2842920" cy="41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1: Figure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952560" y="736560"/>
            <a:ext cx="5079960" cy="2514600"/>
          </a:xfrm>
          <a:prstGeom prst="rect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109520" y="733320"/>
            <a:ext cx="348120" cy="41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261440" y="1193760"/>
            <a:ext cx="512640" cy="32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RN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182600" y="1663560"/>
            <a:ext cx="590400" cy="32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DR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1189080" y="1947960"/>
            <a:ext cx="585720" cy="32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CT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888840" y="2214720"/>
            <a:ext cx="882720" cy="502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91440" anchor="ctr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72396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DR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72396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long exp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952560" y="3301920"/>
            <a:ext cx="2527200" cy="2374920"/>
          </a:xfrm>
          <a:prstGeom prst="rect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957240" y="3298680"/>
            <a:ext cx="348120" cy="41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3547800" y="3298680"/>
            <a:ext cx="348120" cy="41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9" name="" descr=""/>
          <p:cNvPicPr/>
          <p:nvPr/>
        </p:nvPicPr>
        <p:blipFill>
          <a:blip r:embed="rId1"/>
          <a:stretch/>
        </p:blipFill>
        <p:spPr>
          <a:xfrm>
            <a:off x="1863720" y="1041480"/>
            <a:ext cx="4038480" cy="593640"/>
          </a:xfrm>
          <a:prstGeom prst="rect">
            <a:avLst/>
          </a:prstGeom>
          <a:ln w="0">
            <a:noFill/>
          </a:ln>
        </p:spPr>
      </p:pic>
      <p:pic>
        <p:nvPicPr>
          <p:cNvPr id="60" name="" descr=""/>
          <p:cNvPicPr/>
          <p:nvPr/>
        </p:nvPicPr>
        <p:blipFill>
          <a:blip r:embed="rId2"/>
          <a:stretch/>
        </p:blipFill>
        <p:spPr>
          <a:xfrm>
            <a:off x="1863720" y="1681200"/>
            <a:ext cx="4029120" cy="253800"/>
          </a:xfrm>
          <a:prstGeom prst="rect">
            <a:avLst/>
          </a:prstGeom>
          <a:ln w="0">
            <a:noFill/>
          </a:ln>
        </p:spPr>
      </p:pic>
      <p:pic>
        <p:nvPicPr>
          <p:cNvPr id="61" name="" descr=""/>
          <p:cNvPicPr/>
          <p:nvPr/>
        </p:nvPicPr>
        <p:blipFill>
          <a:blip r:embed="rId3"/>
          <a:stretch/>
        </p:blipFill>
        <p:spPr>
          <a:xfrm>
            <a:off x="1866960" y="1981080"/>
            <a:ext cx="4025880" cy="266760"/>
          </a:xfrm>
          <a:prstGeom prst="rect">
            <a:avLst/>
          </a:prstGeom>
          <a:ln w="0">
            <a:noFill/>
          </a:ln>
        </p:spPr>
      </p:pic>
      <p:pic>
        <p:nvPicPr>
          <p:cNvPr id="62" name="" descr=""/>
          <p:cNvPicPr/>
          <p:nvPr/>
        </p:nvPicPr>
        <p:blipFill>
          <a:blip r:embed="rId4"/>
          <a:stretch/>
        </p:blipFill>
        <p:spPr>
          <a:xfrm>
            <a:off x="1882800" y="2332080"/>
            <a:ext cx="4008240" cy="266760"/>
          </a:xfrm>
          <a:prstGeom prst="rect">
            <a:avLst/>
          </a:prstGeom>
          <a:ln w="0">
            <a:noFill/>
          </a:ln>
        </p:spPr>
      </p:pic>
      <p:sp>
        <p:nvSpPr>
          <p:cNvPr id="63" name=""/>
          <p:cNvSpPr/>
          <p:nvPr/>
        </p:nvSpPr>
        <p:spPr>
          <a:xfrm>
            <a:off x="2048760" y="2708280"/>
            <a:ext cx="506520" cy="28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H2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2881800" y="2708280"/>
            <a:ext cx="421200" cy="28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Y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3697560" y="2708280"/>
            <a:ext cx="380160" cy="28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 rot="5400000">
            <a:off x="4642200" y="1764000"/>
            <a:ext cx="142920" cy="2411640"/>
          </a:xfrm>
          <a:custGeom>
            <a:avLst/>
            <a:gdLst>
              <a:gd name="textAreaLeft" fmla="*/ 0 w 142920"/>
              <a:gd name="textAreaRight" fmla="*/ 51480 w 142920"/>
              <a:gd name="textAreaTop" fmla="*/ 62640 h 2411640"/>
              <a:gd name="textAreaBottom" fmla="*/ 2349000 h 24116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4309920" y="3002040"/>
            <a:ext cx="801720" cy="28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D/sec6-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4386240" y="2708280"/>
            <a:ext cx="633600" cy="28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-Sfi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5189400" y="2708280"/>
            <a:ext cx="592200" cy="28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-Pac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 rot="5400000">
            <a:off x="2254680" y="2315160"/>
            <a:ext cx="103320" cy="784440"/>
          </a:xfrm>
          <a:custGeom>
            <a:avLst/>
            <a:gdLst>
              <a:gd name="textAreaLeft" fmla="*/ 0 w 103320"/>
              <a:gd name="textAreaRight" fmla="*/ 37440 w 103320"/>
              <a:gd name="textAreaTop" fmla="*/ 20160 h 784440"/>
              <a:gd name="textAreaBottom" fmla="*/ 764280 h 7844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 rot="5400000">
            <a:off x="3057840" y="2315160"/>
            <a:ext cx="103320" cy="784440"/>
          </a:xfrm>
          <a:custGeom>
            <a:avLst/>
            <a:gdLst>
              <a:gd name="textAreaLeft" fmla="*/ 0 w 103320"/>
              <a:gd name="textAreaRight" fmla="*/ 37440 w 103320"/>
              <a:gd name="textAreaTop" fmla="*/ 20160 h 784440"/>
              <a:gd name="textAreaBottom" fmla="*/ 764280 h 7844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 rot="5400000">
            <a:off x="3862800" y="2315160"/>
            <a:ext cx="103320" cy="784440"/>
          </a:xfrm>
          <a:custGeom>
            <a:avLst/>
            <a:gdLst>
              <a:gd name="textAreaLeft" fmla="*/ 0 w 103320"/>
              <a:gd name="textAreaRight" fmla="*/ 37440 w 103320"/>
              <a:gd name="textAreaTop" fmla="*/ 20160 h 784440"/>
              <a:gd name="textAreaBottom" fmla="*/ 764280 h 7844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 rot="5400000">
            <a:off x="4667760" y="2315160"/>
            <a:ext cx="103320" cy="784080"/>
          </a:xfrm>
          <a:custGeom>
            <a:avLst/>
            <a:gdLst>
              <a:gd name="textAreaLeft" fmla="*/ 0 w 103320"/>
              <a:gd name="textAreaRight" fmla="*/ 37440 w 103320"/>
              <a:gd name="textAreaTop" fmla="*/ 20160 h 784080"/>
              <a:gd name="textAreaBottom" fmla="*/ 763920 h 7840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 rot="5400000">
            <a:off x="5470920" y="2315160"/>
            <a:ext cx="103320" cy="784440"/>
          </a:xfrm>
          <a:custGeom>
            <a:avLst/>
            <a:gdLst>
              <a:gd name="textAreaLeft" fmla="*/ 0 w 103320"/>
              <a:gd name="textAreaRight" fmla="*/ 37440 w 103320"/>
              <a:gd name="textAreaTop" fmla="*/ 20160 h 784440"/>
              <a:gd name="textAreaBottom" fmla="*/ 764280 h 7844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3543480" y="3301920"/>
            <a:ext cx="2490480" cy="2374920"/>
          </a:xfrm>
          <a:prstGeom prst="rect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952560" y="5727600"/>
            <a:ext cx="2527200" cy="2362320"/>
          </a:xfrm>
          <a:prstGeom prst="rect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957240" y="5724360"/>
            <a:ext cx="348120" cy="41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3543480" y="5727600"/>
            <a:ext cx="2490480" cy="2362320"/>
          </a:xfrm>
          <a:prstGeom prst="rect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3548520" y="5724360"/>
            <a:ext cx="335880" cy="41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 rot="5400000">
            <a:off x="2827800" y="4941000"/>
            <a:ext cx="142920" cy="934920"/>
          </a:xfrm>
          <a:custGeom>
            <a:avLst/>
            <a:gdLst>
              <a:gd name="textAreaLeft" fmla="*/ 0 w 142920"/>
              <a:gd name="textAreaRight" fmla="*/ 51480 w 142920"/>
              <a:gd name="textAreaTop" fmla="*/ 24120 h 934920"/>
              <a:gd name="textAreaBottom" fmla="*/ 910800 h 934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2506680" y="5440320"/>
            <a:ext cx="801720" cy="28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D/sec6-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 rot="5400000">
            <a:off x="5418720" y="4940640"/>
            <a:ext cx="142920" cy="935280"/>
          </a:xfrm>
          <a:custGeom>
            <a:avLst/>
            <a:gdLst>
              <a:gd name="textAreaLeft" fmla="*/ 0 w 142920"/>
              <a:gd name="textAreaRight" fmla="*/ 51480 w 142920"/>
              <a:gd name="textAreaTop" fmla="*/ 24120 h 935280"/>
              <a:gd name="textAreaBottom" fmla="*/ 911160 h 9352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5097600" y="5440320"/>
            <a:ext cx="801720" cy="28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D/sec6-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 rot="5400000">
            <a:off x="2827800" y="7366680"/>
            <a:ext cx="142560" cy="934920"/>
          </a:xfrm>
          <a:custGeom>
            <a:avLst/>
            <a:gdLst>
              <a:gd name="textAreaLeft" fmla="*/ 0 w 142560"/>
              <a:gd name="textAreaRight" fmla="*/ 51480 w 142560"/>
              <a:gd name="textAreaTop" fmla="*/ 24120 h 934920"/>
              <a:gd name="textAreaBottom" fmla="*/ 910800 h 934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2506680" y="7866000"/>
            <a:ext cx="801720" cy="28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D/sec6-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 rot="5400000">
            <a:off x="5090760" y="7103880"/>
            <a:ext cx="142920" cy="1511280"/>
          </a:xfrm>
          <a:custGeom>
            <a:avLst/>
            <a:gdLst>
              <a:gd name="textAreaLeft" fmla="*/ 0 w 142920"/>
              <a:gd name="textAreaRight" fmla="*/ 51480 w 142920"/>
              <a:gd name="textAreaTop" fmla="*/ 39240 h 1511280"/>
              <a:gd name="textAreaBottom" fmla="*/ 1472040 h 15112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4754520" y="7866000"/>
            <a:ext cx="801720" cy="28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D/sec6-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/>
  <cp:revision>0</cp:revision>
  <dc:subject/>
  <dc:title/>
</cp:coreProperties>
</file>